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9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132" autoAdjust="0"/>
    <p:restoredTop sz="93738" autoAdjust="0"/>
  </p:normalViewPr>
  <p:slideViewPr>
    <p:cSldViewPr snapToGrid="0">
      <p:cViewPr varScale="1">
        <p:scale>
          <a:sx n="45" d="100"/>
          <a:sy n="45" d="100"/>
        </p:scale>
        <p:origin x="13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14431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04164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3529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32239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821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82183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2106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48702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05300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47235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89269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44411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6B01C46-8421-4A72-9B72-0F04459AE4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2133" y="1183340"/>
            <a:ext cx="4183671" cy="559435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B6EB3A5-2DE1-4A00-89E4-618C86A17C3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1" y="7025341"/>
            <a:ext cx="4183672" cy="559435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9A72E87-B9BB-4E0F-9C20-D03678A8E6D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2133" y="7025341"/>
            <a:ext cx="4183671" cy="559435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3FD36AA-518C-4F99-9B91-091334DC029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999" y="1183340"/>
            <a:ext cx="4183671" cy="559435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0914CC7-2D24-447A-B3E7-7AAA0C864E21}"/>
              </a:ext>
            </a:extLst>
          </p:cNvPr>
          <p:cNvSpPr txBox="1"/>
          <p:nvPr/>
        </p:nvSpPr>
        <p:spPr>
          <a:xfrm>
            <a:off x="887506" y="12882282"/>
            <a:ext cx="10596282" cy="7746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2. CD45-positive cells are present in hair follicle-like structures at the edge of healed dermal wounds of mice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Dermal sections of mouse wounds  on day 14 post injury were stained with CD45 antibody (green). DAPI (blue) was used as a nuclear counterstain. Scale bars in all images were 50 µm. 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B8E64D5E-0F8B-4930-9AE9-9C3523FF202E}"/>
              </a:ext>
            </a:extLst>
          </p:cNvPr>
          <p:cNvCxnSpPr>
            <a:cxnSpLocks/>
          </p:cNvCxnSpPr>
          <p:nvPr/>
        </p:nvCxnSpPr>
        <p:spPr>
          <a:xfrm>
            <a:off x="9572173" y="12380686"/>
            <a:ext cx="508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CB5EF71C-D497-4723-8052-4A65E2D451F4}"/>
              </a:ext>
            </a:extLst>
          </p:cNvPr>
          <p:cNvCxnSpPr>
            <a:cxnSpLocks/>
          </p:cNvCxnSpPr>
          <p:nvPr/>
        </p:nvCxnSpPr>
        <p:spPr>
          <a:xfrm>
            <a:off x="5181602" y="12380686"/>
            <a:ext cx="508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FAAC4575-E1D6-421B-84E8-5570762DC91E}"/>
              </a:ext>
            </a:extLst>
          </p:cNvPr>
          <p:cNvCxnSpPr>
            <a:cxnSpLocks/>
          </p:cNvCxnSpPr>
          <p:nvPr/>
        </p:nvCxnSpPr>
        <p:spPr>
          <a:xfrm>
            <a:off x="9572173" y="6596743"/>
            <a:ext cx="508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E773DCE3-BA1C-45EB-90FB-4611EE35C6EB}"/>
              </a:ext>
            </a:extLst>
          </p:cNvPr>
          <p:cNvCxnSpPr>
            <a:cxnSpLocks/>
          </p:cNvCxnSpPr>
          <p:nvPr/>
        </p:nvCxnSpPr>
        <p:spPr>
          <a:xfrm>
            <a:off x="5181602" y="6574972"/>
            <a:ext cx="508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1007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0</TotalTime>
  <Words>59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nyuan</dc:creator>
  <cp:lastModifiedBy>chn off31</cp:lastModifiedBy>
  <cp:revision>65</cp:revision>
  <dcterms:created xsi:type="dcterms:W3CDTF">2018-08-16T19:41:08Z</dcterms:created>
  <dcterms:modified xsi:type="dcterms:W3CDTF">2022-06-15T08:49:29Z</dcterms:modified>
</cp:coreProperties>
</file>